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66" r:id="rId2"/>
  </p:sldIdLst>
  <p:sldSz cx="6480175" cy="8999538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A9A9"/>
    <a:srgbClr val="CAC8C8"/>
    <a:srgbClr val="DCDADA"/>
    <a:srgbClr val="E1DFDF"/>
    <a:srgbClr val="CE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49" autoAdjust="0"/>
    <p:restoredTop sz="92383" autoAdjust="0"/>
  </p:normalViewPr>
  <p:slideViewPr>
    <p:cSldViewPr snapToGrid="0">
      <p:cViewPr>
        <p:scale>
          <a:sx n="150" d="100"/>
          <a:sy n="150" d="100"/>
        </p:scale>
        <p:origin x="2136" y="-1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D26D49-6D75-4625-B197-77F31D63B0E7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93925" y="1241425"/>
            <a:ext cx="24098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B8D57-DE94-4AFA-B20B-8668DBE2A06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6690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472842"/>
            <a:ext cx="5508149" cy="313317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726842"/>
            <a:ext cx="4860131" cy="2172804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9432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334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79142"/>
            <a:ext cx="1397288" cy="7626692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79142"/>
            <a:ext cx="4110861" cy="7626692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5803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4775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243638"/>
            <a:ext cx="5589151" cy="3743557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022610"/>
            <a:ext cx="5589151" cy="1968648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040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395710"/>
            <a:ext cx="2754074" cy="571012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395710"/>
            <a:ext cx="2754074" cy="571012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4471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79144"/>
            <a:ext cx="5589151" cy="173949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06137"/>
            <a:ext cx="2741417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287331"/>
            <a:ext cx="2741417" cy="48351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06137"/>
            <a:ext cx="2754918" cy="1081194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287331"/>
            <a:ext cx="2754918" cy="4835169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8910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6892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712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295769"/>
            <a:ext cx="3280589" cy="6395505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789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99969"/>
            <a:ext cx="2090025" cy="2099892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295769"/>
            <a:ext cx="3280589" cy="6395505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699862"/>
            <a:ext cx="2090025" cy="5001827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98570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79144"/>
            <a:ext cx="5589151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395710"/>
            <a:ext cx="5589151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183C8-E0B2-46DE-9AA7-B1FF3B213765}" type="datetimeFigureOut">
              <a:rPr lang="it-IT" smtClean="0"/>
              <a:t>19/07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341240"/>
            <a:ext cx="218705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341240"/>
            <a:ext cx="1458039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C1AA9-1107-40EF-B77D-E4C235419D70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26866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7878"/>
          <a:stretch/>
        </p:blipFill>
        <p:spPr>
          <a:xfrm>
            <a:off x="656907" y="2521617"/>
            <a:ext cx="5166360" cy="3248988"/>
          </a:xfrm>
          <a:prstGeom prst="rect">
            <a:avLst/>
          </a:prstGeom>
        </p:spPr>
      </p:pic>
      <p:sp>
        <p:nvSpPr>
          <p:cNvPr id="3" name="Rettangolo 2"/>
          <p:cNvSpPr/>
          <p:nvPr/>
        </p:nvSpPr>
        <p:spPr>
          <a:xfrm>
            <a:off x="999496" y="5770605"/>
            <a:ext cx="472168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  <a:tabLst>
                <a:tab pos="2400300" algn="l"/>
              </a:tabLst>
            </a:pPr>
            <a:r>
              <a:rPr lang="en-US" sz="8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HIV-DNA decrease at different time-points. </a:t>
            </a:r>
            <a:r>
              <a:rPr lang="en-US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l-GR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IV-DNA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as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culated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he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mce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HIV-DNA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fferent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ime-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ints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sidered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P-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alues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were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it-IT" sz="8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timated</a:t>
            </a:r>
            <a:r>
              <a:rPr lang="it-IT" sz="8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by Mann-Whitney test.</a:t>
            </a:r>
            <a:endParaRPr lang="it-IT" sz="8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064457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3</TotalTime>
  <Words>32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sana Scutari</dc:creator>
  <cp:lastModifiedBy>MDPI-52</cp:lastModifiedBy>
  <cp:revision>87</cp:revision>
  <dcterms:created xsi:type="dcterms:W3CDTF">2020-07-11T09:38:02Z</dcterms:created>
  <dcterms:modified xsi:type="dcterms:W3CDTF">2021-07-19T13:13:53Z</dcterms:modified>
</cp:coreProperties>
</file>